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slides/slide22.xml" ContentType="application/vnd.openxmlformats-officedocument.presentationml.slide+xml"/>
  <Override PartName="/ppt/slides/slide23.xml" ContentType="application/vnd.openxmlformats-officedocument.presentationml.slide+xml"/>
  <Override PartName="/ppt/slides/slide24.xml" ContentType="application/vnd.openxmlformats-officedocument.presentationml.slide+xml"/>
  <Override PartName="/ppt/slides/slide25.xml" ContentType="application/vnd.openxmlformats-officedocument.presentationml.slide+xml"/>
  <Override PartName="/ppt/slides/slide2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82" r:id="rId2"/>
    <p:sldId id="257" r:id="rId3"/>
    <p:sldId id="259" r:id="rId4"/>
    <p:sldId id="260" r:id="rId5"/>
    <p:sldId id="266" r:id="rId6"/>
    <p:sldId id="281" r:id="rId7"/>
    <p:sldId id="261" r:id="rId8"/>
    <p:sldId id="280" r:id="rId9"/>
    <p:sldId id="264" r:id="rId10"/>
    <p:sldId id="270" r:id="rId11"/>
    <p:sldId id="272" r:id="rId12"/>
    <p:sldId id="276" r:id="rId13"/>
    <p:sldId id="275" r:id="rId14"/>
    <p:sldId id="269" r:id="rId15"/>
    <p:sldId id="268" r:id="rId16"/>
    <p:sldId id="279" r:id="rId17"/>
    <p:sldId id="278" r:id="rId18"/>
    <p:sldId id="258" r:id="rId19"/>
    <p:sldId id="265" r:id="rId20"/>
    <p:sldId id="274" r:id="rId21"/>
    <p:sldId id="277" r:id="rId22"/>
    <p:sldId id="263" r:id="rId23"/>
    <p:sldId id="273" r:id="rId24"/>
    <p:sldId id="262" r:id="rId25"/>
    <p:sldId id="267" r:id="rId26"/>
    <p:sldId id="271" r:id="rId27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9" d="100"/>
          <a:sy n="69" d="100"/>
        </p:scale>
        <p:origin x="557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slide" Target="slides/slide25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slide" Target="slides/slide24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29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slide" Target="slides/slide23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slide" Target="slides/slide22.xml"/><Relationship Id="rId28" Type="http://schemas.openxmlformats.org/officeDocument/2006/relationships/presProps" Target="presProps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31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slide" Target="slides/slide26.xml"/><Relationship Id="rId30" Type="http://schemas.openxmlformats.org/officeDocument/2006/relationships/theme" Target="theme/them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649156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1579507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280159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677307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6779487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6904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1192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91017928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6908248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012754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5249018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D58CB9A-82B4-4FEB-A1EC-137E580E05D0}" type="datetimeFigureOut">
              <a:rPr lang="zh-CN" altLang="en-US" smtClean="0"/>
              <a:t>2020/4/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F4E0EA-1A51-492A-A105-8D83C29706BE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8901283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17.png"/><Relationship Id="rId1" Type="http://schemas.openxmlformats.org/officeDocument/2006/relationships/slideLayout" Target="../slideLayouts/slideLayout2.xml"/></Relationships>
</file>

<file path=ppt/slides/_rels/slide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18.png"/><Relationship Id="rId1" Type="http://schemas.openxmlformats.org/officeDocument/2006/relationships/slideLayout" Target="../slideLayouts/slideLayout2.xml"/></Relationships>
</file>

<file path=ppt/slides/_rels/slide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9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2" Type="http://schemas.openxmlformats.org/officeDocument/2006/relationships/image" Target="../media/image20.png"/><Relationship Id="rId1" Type="http://schemas.openxmlformats.org/officeDocument/2006/relationships/slideLayout" Target="../slideLayouts/slideLayout2.xml"/></Relationships>
</file>

<file path=ppt/slides/_rels/slide2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1.png"/><Relationship Id="rId1" Type="http://schemas.openxmlformats.org/officeDocument/2006/relationships/slideLayout" Target="../slideLayouts/slideLayout2.xml"/></Relationships>
</file>

<file path=ppt/slides/_rels/slide2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2.xml"/></Relationships>
</file>

<file path=ppt/slides/_rels/slide2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3.png"/><Relationship Id="rId1" Type="http://schemas.openxmlformats.org/officeDocument/2006/relationships/slideLayout" Target="../slideLayouts/slideLayout2.xml"/></Relationships>
</file>

<file path=ppt/slides/_rels/slide2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4.png"/><Relationship Id="rId1" Type="http://schemas.openxmlformats.org/officeDocument/2006/relationships/slideLayout" Target="../slideLayouts/slideLayout2.xml"/></Relationships>
</file>

<file path=ppt/slides/_rels/slide2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5.png"/><Relationship Id="rId1" Type="http://schemas.openxmlformats.org/officeDocument/2006/relationships/slideLayout" Target="../slideLayouts/slideLayout2.xml"/></Relationships>
</file>

<file path=ppt/slides/_rels/slide2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88BCC-89E3-459C-8C12-EBE6A3330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&gt;AT3G21630.1 LYK1/CERK1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681DD98B-51FB-473B-90C8-6581CFDD94F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32288" y="2618144"/>
            <a:ext cx="6279424" cy="276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75919269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34737.1 PbrLYK3a2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E5B9A513-EFF1-42F3-A435-46B92FB3002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20857" y="2629575"/>
            <a:ext cx="6302286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6093974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36151.1 PbrLYK3b1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E1DCBC5B-4C25-46B5-B0E7-4B0B4F0CA95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36098" y="2633385"/>
            <a:ext cx="6271803" cy="273581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63281028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88BCC-89E3-459C-8C12-EBE6A3330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&gt;AT2G23770.1 LYK4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5D19D232-672D-4BC4-A40B-6FDBBE74F23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28477" y="2606713"/>
            <a:ext cx="6287045" cy="278916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47778175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88BCC-89E3-459C-8C12-EBE6A3330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&gt;AT2G33580.1 LYK5</a:t>
            </a:r>
            <a:endParaRPr lang="zh-CN" altLang="en-US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9F6FE9AD-6FCE-4367-A58B-C0715E4F8A9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36098" y="2610523"/>
            <a:ext cx="6271803" cy="2781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57606195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22856.1 PbrLYK4/5a1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DF39B32E-B0CC-411C-A910-F28D9E3C29B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32288" y="2610523"/>
            <a:ext cx="6279424" cy="2781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854982176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22855.1 PbrLYK4/5b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75FD376B-392C-4C2E-A1E8-A28B3EB3AA3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32288" y="2591472"/>
            <a:ext cx="6279424" cy="2819644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47245578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88BCC-89E3-459C-8C12-EBE6A3330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&gt;AT1G21880.2 LYM1</a:t>
            </a:r>
            <a:endParaRPr lang="zh-CN" altLang="en-US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3AF8A2AB-D487-42FE-9895-FA9221DE985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28477" y="2618144"/>
            <a:ext cx="6287045" cy="276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76370391"/>
      </p:ext>
    </p:extLst>
  </p:cSld>
  <p:clrMapOvr>
    <a:masterClrMapping/>
  </p:clrMapOvr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88BCC-89E3-459C-8C12-EBE6A3330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AT1G77630.1 LYM3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314332F1-8AB3-495B-86B6-09182B74557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39908" y="2637196"/>
            <a:ext cx="6264183" cy="272819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05712064"/>
      </p:ext>
    </p:extLst>
  </p:cSld>
  <p:clrMapOvr>
    <a:masterClrMapping/>
  </p:clrMapOvr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02167.1 PbrLYM1/3-1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D72A6A4E-A1F8-4A73-B548-6894A76575B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386564" y="2629575"/>
            <a:ext cx="6370872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70482945"/>
      </p:ext>
    </p:extLst>
  </p:cSld>
  <p:clrMapOvr>
    <a:masterClrMapping/>
  </p:clrMapOvr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Pbr020280.1 PbrLYM1/3-2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E46C9817-B4ED-4D0E-83BD-A9DA438CCED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20857" y="2641006"/>
            <a:ext cx="6302286" cy="2720576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754618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A7DFD4A2-2F5F-4BD6-9EFD-64678BA39A9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00107.1 PbrLYK1a </a:t>
            </a:r>
            <a:endParaRPr lang="zh-CN" altLang="en-US" dirty="0"/>
          </a:p>
        </p:txBody>
      </p:sp>
      <p:pic>
        <p:nvPicPr>
          <p:cNvPr id="4" name="图片 3">
            <a:extLst>
              <a:ext uri="{FF2B5EF4-FFF2-40B4-BE49-F238E27FC236}">
                <a16:creationId xmlns:a16="http://schemas.microsoft.com/office/drawing/2014/main" id="{F95A9BF2-229D-4E39-8C27-EE24234CC23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3236" y="2045850"/>
            <a:ext cx="6317527" cy="276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200828906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40557.1 PbrLYM1/3-3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3D9161F8-2438-45F2-8F37-C0CA9ADF3856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28477" y="2644816"/>
            <a:ext cx="6287045" cy="271295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201311788"/>
      </p:ext>
    </p:extLst>
  </p:cSld>
  <p:clrMapOvr>
    <a:masterClrMapping/>
  </p:clrMapOvr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88BCC-89E3-459C-8C12-EBE6A3330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&gt;AT2G17120.1 LYM2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A983E644-FB91-4259-B5A8-897FAB081B13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367512" y="2614334"/>
            <a:ext cx="6408975" cy="2773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95599506"/>
      </p:ext>
    </p:extLst>
  </p:cSld>
  <p:clrMapOvr>
    <a:masterClrMapping/>
  </p:clrMapOvr>
</p:sld>
</file>

<file path=ppt/slides/slide2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16347.1 PbrLYM2-1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6B86B7AD-6EB4-4DEB-A12E-866B204D006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394184" y="2610523"/>
            <a:ext cx="6355631" cy="278154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8024239"/>
      </p:ext>
    </p:extLst>
  </p:cSld>
  <p:clrMapOvr>
    <a:masterClrMapping/>
  </p:clrMapOvr>
</p:sld>
</file>

<file path=ppt/slides/slide2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39238.2 PbrLYM2-2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108EDC32-DB71-4889-B303-E5006EDB0FD2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01805" y="2625765"/>
            <a:ext cx="6340389" cy="27510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543106329"/>
      </p:ext>
    </p:extLst>
  </p:cSld>
  <p:clrMapOvr>
    <a:masterClrMapping/>
  </p:clrMapOvr>
</p:sld>
</file>

<file path=ppt/slides/slide2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14715.1 PbrNFP1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20412121-BA5A-48D4-B404-151FC689EBF1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43719" y="2625765"/>
            <a:ext cx="6256562" cy="275105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630342636"/>
      </p:ext>
    </p:extLst>
  </p:cSld>
  <p:clrMapOvr>
    <a:masterClrMapping/>
  </p:clrMapOvr>
</p:sld>
</file>

<file path=ppt/slides/slide2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Pbr022854.1 PbrNFP2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1DC550E4-3783-4851-B0B8-4B827EC792FE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05615" y="2618144"/>
            <a:ext cx="6332769" cy="276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5749815"/>
      </p:ext>
    </p:extLst>
  </p:cSld>
  <p:clrMapOvr>
    <a:masterClrMapping/>
  </p:clrMapOvr>
</p:sld>
</file>

<file path=ppt/slides/slide2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35317.1 PbrWAKL1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5818F472-19D8-4FD9-8808-4D48182423EC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28477" y="2614334"/>
            <a:ext cx="6287045" cy="277392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763759132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05151.1 PbrLYK1b1 </a:t>
            </a:r>
            <a:endParaRPr lang="zh-CN" altLang="en-US" dirty="0"/>
          </a:p>
        </p:txBody>
      </p:sp>
      <p:pic>
        <p:nvPicPr>
          <p:cNvPr id="5" name="内容占位符 3">
            <a:extLst>
              <a:ext uri="{FF2B5EF4-FFF2-40B4-BE49-F238E27FC236}">
                <a16:creationId xmlns:a16="http://schemas.microsoft.com/office/drawing/2014/main" id="{B201FF18-9A10-461E-BB1B-D6D64BEDC2FD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39908" y="2547934"/>
            <a:ext cx="6264183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48761239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05152.1 PbrLYK1b2 </a:t>
            </a:r>
            <a:endParaRPr lang="zh-CN" altLang="en-US" dirty="0"/>
          </a:p>
        </p:txBody>
      </p:sp>
      <p:pic>
        <p:nvPicPr>
          <p:cNvPr id="6" name="内容占位符 3">
            <a:extLst>
              <a:ext uri="{FF2B5EF4-FFF2-40B4-BE49-F238E27FC236}">
                <a16:creationId xmlns:a16="http://schemas.microsoft.com/office/drawing/2014/main" id="{F3E24B4A-34AD-4B3C-B336-C9F35D31EAD8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17046" y="2621954"/>
            <a:ext cx="6309907" cy="275867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908082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Pbr021830.1 PbrLYK1b3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D49206C2-59D1-44D4-AC80-83516FBC33C9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17046" y="2629575"/>
            <a:ext cx="6309907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63790925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88BCC-89E3-459C-8C12-EBE6A3330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&gt;AT3G01840.1 LYK2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C42E0CAF-67C5-43CC-B0D3-8A7E3F7531F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09426" y="2618144"/>
            <a:ext cx="6325148" cy="276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2290606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14439.4 PbrLYK2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5FE54A4A-DB31-408C-8DCA-9C0F1D84627A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01805" y="2629575"/>
            <a:ext cx="6340389" cy="2743438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813388359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BD088BCC-89E3-459C-8C12-EBE6A3330DB0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/>
              <a:t>&gt;AT1G51940.1 LYK3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95347D3B-8F2C-401C-A467-54036F9C310F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39908" y="2618144"/>
            <a:ext cx="6264183" cy="276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497673828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F1B90C1-5E66-450D-AB9A-D41F266D644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CN" dirty="0"/>
              <a:t>&gt;Pbr019107.1 PbrLYK3a1 </a:t>
            </a:r>
            <a:endParaRPr lang="zh-CN" altLang="en-US" dirty="0"/>
          </a:p>
        </p:txBody>
      </p:sp>
      <p:pic>
        <p:nvPicPr>
          <p:cNvPr id="4" name="内容占位符 3">
            <a:extLst>
              <a:ext uri="{FF2B5EF4-FFF2-40B4-BE49-F238E27FC236}">
                <a16:creationId xmlns:a16="http://schemas.microsoft.com/office/drawing/2014/main" id="{1D291786-B8C0-448E-A637-0462610986A4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/>
          <a:stretch>
            <a:fillRect/>
          </a:stretch>
        </p:blipFill>
        <p:spPr>
          <a:xfrm>
            <a:off x="1413236" y="2618144"/>
            <a:ext cx="6317527" cy="276630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4525172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47</TotalTime>
  <Words>77</Words>
  <Application>Microsoft Office PowerPoint</Application>
  <PresentationFormat>全屏显示(4:3)</PresentationFormat>
  <Paragraphs>26</Paragraphs>
  <Slides>26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3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26</vt:i4>
      </vt:variant>
    </vt:vector>
  </HeadingPairs>
  <TitlesOfParts>
    <vt:vector size="30" baseType="lpstr">
      <vt:lpstr>Arial</vt:lpstr>
      <vt:lpstr>Calibri</vt:lpstr>
      <vt:lpstr>Calibri Light</vt:lpstr>
      <vt:lpstr>Office 主题​​</vt:lpstr>
      <vt:lpstr>&gt;AT3G21630.1 LYK1/CERK1</vt:lpstr>
      <vt:lpstr>&gt;Pbr000107.1 PbrLYK1a </vt:lpstr>
      <vt:lpstr>&gt;Pbr005151.1 PbrLYK1b1 </vt:lpstr>
      <vt:lpstr>&gt;Pbr005152.1 PbrLYK1b2 </vt:lpstr>
      <vt:lpstr>Pbr021830.1 PbrLYK1b3 </vt:lpstr>
      <vt:lpstr>&gt;AT3G01840.1 LYK2</vt:lpstr>
      <vt:lpstr>&gt;Pbr014439.4 PbrLYK2 </vt:lpstr>
      <vt:lpstr>&gt;AT1G51940.1 LYK3</vt:lpstr>
      <vt:lpstr>&gt;Pbr019107.1 PbrLYK3a1 </vt:lpstr>
      <vt:lpstr>&gt;Pbr034737.1 PbrLYK3a2 </vt:lpstr>
      <vt:lpstr>&gt;Pbr036151.1 PbrLYK3b1 </vt:lpstr>
      <vt:lpstr>&gt;AT2G23770.1 LYK4</vt:lpstr>
      <vt:lpstr>&gt;AT2G33580.1 LYK5</vt:lpstr>
      <vt:lpstr>&gt;Pbr022856.1 PbrLYK4/5a1 </vt:lpstr>
      <vt:lpstr>&gt;Pbr022855.1 PbrLYK4/5b </vt:lpstr>
      <vt:lpstr>&gt;AT1G21880.2 LYM1</vt:lpstr>
      <vt:lpstr>&gt;AT1G77630.1 LYM3</vt:lpstr>
      <vt:lpstr>&gt;Pbr002167.1 PbrLYM1/3-1 </vt:lpstr>
      <vt:lpstr>Pbr020280.1 PbrLYM1/3-2 </vt:lpstr>
      <vt:lpstr>&gt;Pbr040557.1 PbrLYM1/3-3 </vt:lpstr>
      <vt:lpstr>&gt;AT2G17120.1 LYM2</vt:lpstr>
      <vt:lpstr>&gt;Pbr016347.1 PbrLYM2-1 </vt:lpstr>
      <vt:lpstr>&gt;Pbr039238.2 PbrLYM2-2 </vt:lpstr>
      <vt:lpstr>&gt;Pbr014715.1 PbrNFP1 </vt:lpstr>
      <vt:lpstr>Pbr022854.1 PbrNFP2 </vt:lpstr>
      <vt:lpstr>&gt;Pbr035317.1 PbrWAKL1 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启明 陈</dc:creator>
  <cp:lastModifiedBy>陈 启明</cp:lastModifiedBy>
  <cp:revision>5</cp:revision>
  <dcterms:created xsi:type="dcterms:W3CDTF">2019-07-18T00:25:11Z</dcterms:created>
  <dcterms:modified xsi:type="dcterms:W3CDTF">2020-04-04T17:59:54Z</dcterms:modified>
</cp:coreProperties>
</file>